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FF"/>
    <a:srgbClr val="FF3333"/>
    <a:srgbClr val="00CC33"/>
    <a:srgbClr val="FF6600"/>
    <a:srgbClr val="00CC66"/>
    <a:srgbClr val="FF99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34" autoAdjust="0"/>
    <p:restoredTop sz="94660"/>
  </p:normalViewPr>
  <p:slideViewPr>
    <p:cSldViewPr snapToGrid="0">
      <p:cViewPr varScale="1">
        <p:scale>
          <a:sx n="87" d="100"/>
          <a:sy n="87" d="100"/>
        </p:scale>
        <p:origin x="284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7252FE-E85F-4029-B8C4-4883B2F5FDB5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003D27-7819-4861-8EE3-F1BAAF6C1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8197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003D27-7819-4861-8EE3-F1BAAF6C169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139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453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870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583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8919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688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000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658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953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164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69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219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F0809-CCFB-4B9C-A107-9FAF398B8142}" type="datetimeFigureOut">
              <a:rPr lang="en-US" smtClean="0"/>
              <a:t>7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8048A-0EB4-44D5-BD38-1E1E13AE75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919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31241" y="353096"/>
            <a:ext cx="30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655992" y="349439"/>
            <a:ext cx="30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  <a:endParaRPr 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4627782" y="346463"/>
            <a:ext cx="30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  <a:endParaRPr lang="en-US" dirty="0"/>
          </a:p>
        </p:txBody>
      </p:sp>
      <p:grpSp>
        <p:nvGrpSpPr>
          <p:cNvPr id="34" name="Group 33"/>
          <p:cNvGrpSpPr/>
          <p:nvPr/>
        </p:nvGrpSpPr>
        <p:grpSpPr>
          <a:xfrm>
            <a:off x="50481" y="624814"/>
            <a:ext cx="6830888" cy="2274952"/>
            <a:chOff x="50481" y="2766819"/>
            <a:chExt cx="6830888" cy="2274952"/>
          </a:xfrm>
        </p:grpSpPr>
        <p:grpSp>
          <p:nvGrpSpPr>
            <p:cNvPr id="6" name="Group 5"/>
            <p:cNvGrpSpPr/>
            <p:nvPr/>
          </p:nvGrpSpPr>
          <p:grpSpPr>
            <a:xfrm>
              <a:off x="50481" y="2790388"/>
              <a:ext cx="3016552" cy="2249487"/>
              <a:chOff x="50481" y="3091182"/>
              <a:chExt cx="3016552" cy="2249487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2590783" y="4658717"/>
                <a:ext cx="4762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88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581258" y="4492357"/>
                <a:ext cx="4394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50481" y="3091182"/>
              <a:ext cx="2941637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0286" name="Prism 7" r:id="rId4" imgW="2940868" imgH="2250242" progId="Prism7.Document">
                      <p:embed/>
                    </p:oleObj>
                  </mc:Choice>
                  <mc:Fallback>
                    <p:oleObj name="Prism 7" r:id="rId4" imgW="2940868" imgH="2250242" progId="Prism7.Document">
                      <p:embed/>
                      <p:pic>
                        <p:nvPicPr>
                          <p:cNvPr id="5" name="Object 4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50481" y="3091182"/>
                            <a:ext cx="2941637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aphicFrame>
          <p:nvGraphicFramePr>
            <p:cNvPr id="22" name="Object 21"/>
            <p:cNvGraphicFramePr>
              <a:graphicFrameLocks noChangeAspect="1"/>
            </p:cNvGraphicFramePr>
            <p:nvPr>
              <p:extLst/>
            </p:nvPr>
          </p:nvGraphicFramePr>
          <p:xfrm>
            <a:off x="2769741" y="2792284"/>
            <a:ext cx="234632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287" name="Prism 7" r:id="rId6" imgW="2346284" imgH="2250242" progId="Prism7.Document">
                    <p:embed/>
                  </p:oleObj>
                </mc:Choice>
                <mc:Fallback>
                  <p:oleObj name="Prism 7" r:id="rId6" imgW="2346284" imgH="2250242" progId="Prism7.Document">
                    <p:embed/>
                    <p:pic>
                      <p:nvPicPr>
                        <p:cNvPr id="22" name="Object 21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769741" y="2792284"/>
                          <a:ext cx="234632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ct 24"/>
            <p:cNvGraphicFramePr>
              <a:graphicFrameLocks noChangeAspect="1"/>
            </p:cNvGraphicFramePr>
            <p:nvPr>
              <p:extLst/>
            </p:nvPr>
          </p:nvGraphicFramePr>
          <p:xfrm>
            <a:off x="4598544" y="2766819"/>
            <a:ext cx="2282825" cy="1985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288" name="Prism 7" r:id="rId8" imgW="2282180" imgH="1985169" progId="Prism7.Document">
                    <p:embed/>
                  </p:oleObj>
                </mc:Choice>
                <mc:Fallback>
                  <p:oleObj name="Prism 7" r:id="rId8" imgW="2282180" imgH="1985169" progId="Prism7.Document">
                    <p:embed/>
                    <p:pic>
                      <p:nvPicPr>
                        <p:cNvPr id="25" name="Object 24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598544" y="2766819"/>
                          <a:ext cx="2282825" cy="1985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9" name="TextBox 28"/>
          <p:cNvSpPr txBox="1"/>
          <p:nvPr/>
        </p:nvSpPr>
        <p:spPr>
          <a:xfrm>
            <a:off x="231241" y="2793579"/>
            <a:ext cx="30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655992" y="2789922"/>
            <a:ext cx="30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627782" y="2786946"/>
            <a:ext cx="305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grpSp>
        <p:nvGrpSpPr>
          <p:cNvPr id="35" name="Group 34"/>
          <p:cNvGrpSpPr/>
          <p:nvPr/>
        </p:nvGrpSpPr>
        <p:grpSpPr>
          <a:xfrm>
            <a:off x="50480" y="2984736"/>
            <a:ext cx="7165889" cy="2378116"/>
            <a:chOff x="50480" y="5367381"/>
            <a:chExt cx="7165889" cy="2378116"/>
          </a:xfrm>
        </p:grpSpPr>
        <p:grpSp>
          <p:nvGrpSpPr>
            <p:cNvPr id="28" name="Group 27"/>
            <p:cNvGrpSpPr/>
            <p:nvPr/>
          </p:nvGrpSpPr>
          <p:grpSpPr>
            <a:xfrm>
              <a:off x="50480" y="5496010"/>
              <a:ext cx="3016553" cy="2249487"/>
              <a:chOff x="50480" y="5496010"/>
              <a:chExt cx="3016553" cy="2249487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2590783" y="7068430"/>
                <a:ext cx="4762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03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581258" y="6902070"/>
                <a:ext cx="4394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97</a:t>
                </a:r>
                <a:endParaRPr lang="es-E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7" name="Object 26"/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50480" y="5496010"/>
              <a:ext cx="2941637" cy="224948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0289" name="Prism 7" r:id="rId10" imgW="2940868" imgH="2250242" progId="Prism7.Document">
                      <p:embed/>
                    </p:oleObj>
                  </mc:Choice>
                  <mc:Fallback>
                    <p:oleObj name="Prism 7" r:id="rId10" imgW="2940868" imgH="2250242" progId="Prism7.Document">
                      <p:embed/>
                      <p:pic>
                        <p:nvPicPr>
                          <p:cNvPr id="27" name="Object 26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50480" y="5496010"/>
                            <a:ext cx="2941637" cy="224948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aphicFrame>
          <p:nvGraphicFramePr>
            <p:cNvPr id="32" name="Object 31"/>
            <p:cNvGraphicFramePr>
              <a:graphicFrameLocks noChangeAspect="1"/>
            </p:cNvGraphicFramePr>
            <p:nvPr>
              <p:extLst/>
            </p:nvPr>
          </p:nvGraphicFramePr>
          <p:xfrm>
            <a:off x="2729932" y="5495201"/>
            <a:ext cx="2949575" cy="22494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290" name="Prism 7" r:id="rId12" imgW="2950232" imgH="2250242" progId="Prism7.Document">
                    <p:embed/>
                  </p:oleObj>
                </mc:Choice>
                <mc:Fallback>
                  <p:oleObj name="Prism 7" r:id="rId12" imgW="2950232" imgH="2250242" progId="Prism7.Document">
                    <p:embed/>
                    <p:pic>
                      <p:nvPicPr>
                        <p:cNvPr id="32" name="Object 31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2729932" y="5495201"/>
                          <a:ext cx="2949575" cy="22494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Object 32"/>
            <p:cNvGraphicFramePr>
              <a:graphicFrameLocks noChangeAspect="1"/>
            </p:cNvGraphicFramePr>
            <p:nvPr>
              <p:extLst/>
            </p:nvPr>
          </p:nvGraphicFramePr>
          <p:xfrm>
            <a:off x="4933544" y="5367381"/>
            <a:ext cx="2282825" cy="19859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291" name="Prism 7" r:id="rId14" imgW="2282180" imgH="1985169" progId="Prism7.Document">
                    <p:embed/>
                  </p:oleObj>
                </mc:Choice>
                <mc:Fallback>
                  <p:oleObj name="Prism 7" r:id="rId14" imgW="2282180" imgH="1985169" progId="Prism7.Document">
                    <p:embed/>
                    <p:pic>
                      <p:nvPicPr>
                        <p:cNvPr id="33" name="Object 32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933544" y="5367381"/>
                          <a:ext cx="2282825" cy="19859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0B4B6597-6E2A-4D97-84DD-E29CF31956AC}"/>
              </a:ext>
            </a:extLst>
          </p:cNvPr>
          <p:cNvSpPr/>
          <p:nvPr/>
        </p:nvSpPr>
        <p:spPr>
          <a:xfrm>
            <a:off x="384123" y="5457110"/>
            <a:ext cx="6170914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ea typeface="Times New Roman" panose="02020603050405020304" pitchFamily="18" charset="0"/>
              </a:rPr>
              <a:t>Figure S2. </a:t>
            </a:r>
            <a:r>
              <a:rPr lang="en-US" sz="1400" dirty="0">
                <a:ea typeface="Times New Roman" panose="02020603050405020304" pitchFamily="18" charset="0"/>
              </a:rPr>
              <a:t>On-plate analytical and biological variability of the large-scale proteomics workflow. (A) Analytical coefficient of variation (CV) for the 1,000 most abundant proteins quantitated across 13 technical replicates as a function of their ranked abundance. A total of 888 proteins showed CV &lt; 20 (blue dots), and 12 CV &gt; 20 (grey dots). (B) Analytical CV values distributed as follows: 48% of the proteins had CV &lt; 5, 38% ranged from 5 to 10, 13% ranged from 10 to 20, and only 1% showed CV &gt; 20. (C) Analytical variability of the </a:t>
            </a:r>
            <a:r>
              <a:rPr lang="en-US" sz="1400" dirty="0">
                <a:ea typeface="Calibri" panose="020F0502020204030204" pitchFamily="34" charset="0"/>
              </a:rPr>
              <a:t>US Food and Drug Administration</a:t>
            </a:r>
            <a:r>
              <a:rPr lang="en-US" sz="1400" dirty="0">
                <a:ea typeface="Times New Roman" panose="02020603050405020304" pitchFamily="18" charset="0"/>
              </a:rPr>
              <a:t> (FDA)-approved biomarkers. The analytical CV of the 49 FDA biomarkers that could be quantitated was plotted as a function of their ranked abundance. All the biomarkers showed CV &lt; 20. (D) Biological CV for the 1,000 most abundant proteins quantitated across 350 individuals as a function of their ranked abundance. A total of 403 proteins showed CV &lt; 20 (blue dots), and 597 CV &gt; 20 (grey dots). (E) Biological CV values distributed as follows: 28% of the proteins had CV from 10 to 20, 27% ranged from 20 to 30, 19% ranged from 30 to 40, 12% ranged from 40 to 60, and 7% showed CV &gt; 60. (F) Biological variability of the FDA biomarkers. The biological CV of the 49 FDA biomarkers that could be quantitated was plotted as a function of their ranked abundance. A total of 12 proteins showed CV &gt; 20.</a:t>
            </a:r>
          </a:p>
        </p:txBody>
      </p:sp>
    </p:spTree>
    <p:extLst>
      <p:ext uri="{BB962C8B-B14F-4D97-AF65-F5344CB8AC3E}">
        <p14:creationId xmlns:p14="http://schemas.microsoft.com/office/powerpoint/2010/main" val="1076073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552</TotalTime>
  <Words>310</Words>
  <Application>Microsoft Office PowerPoint</Application>
  <PresentationFormat>A4 Paper (210x297 mm)</PresentationFormat>
  <Paragraphs>12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</vt:vector>
  </TitlesOfParts>
  <Company>C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efanía Núñez Sánchez</dc:creator>
  <cp:lastModifiedBy>Emilio Camafeita</cp:lastModifiedBy>
  <cp:revision>766</cp:revision>
  <dcterms:created xsi:type="dcterms:W3CDTF">2019-04-24T13:07:55Z</dcterms:created>
  <dcterms:modified xsi:type="dcterms:W3CDTF">2024-07-12T08:53:54Z</dcterms:modified>
</cp:coreProperties>
</file>